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6" d="100"/>
          <a:sy n="106" d="100"/>
        </p:scale>
        <p:origin x="75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5C0BED-7DD5-AD9C-0745-ED3BA3F9EFE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462C244-D124-26B8-6269-ED39DBA972C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2B186C-894E-29AD-9B14-7D014B50CF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855BA-ED2C-4921-85A3-0B137AC57079}" type="datetimeFigureOut">
              <a:rPr lang="en-US" smtClean="0"/>
              <a:t>3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19B775-5F0C-EA0F-D952-96840FAC71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F188B2-B651-C603-7A98-1F13835970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525C67-CAC0-4D02-B484-862DB48D8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37645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515CED-4B9D-5683-948E-A090A8DC40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06AE001-7441-9C75-806B-D7923E1BC8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9FBC63-64B1-5250-0EAA-D31D55A526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855BA-ED2C-4921-85A3-0B137AC57079}" type="datetimeFigureOut">
              <a:rPr lang="en-US" smtClean="0"/>
              <a:t>3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D865D7-056B-1750-BBE8-D812161E79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7089BE-6748-CF7F-D683-B43B180F7B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525C67-CAC0-4D02-B484-862DB48D8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61939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891A993-3772-6E1C-62B8-49D74F53998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C026664-7CCB-1260-ED71-ABFE598A16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3408BC-E36C-D7B3-7503-AB169D441E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855BA-ED2C-4921-85A3-0B137AC57079}" type="datetimeFigureOut">
              <a:rPr lang="en-US" smtClean="0"/>
              <a:t>3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30B72C-3EB5-0E19-AE4A-CF4A568F11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0B8405-9397-D18D-3466-7D64AF024D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525C67-CAC0-4D02-B484-862DB48D8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66593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C756B8-DA30-1648-23D8-4AAF939B17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0F182C-FB96-07A2-8FB9-A68E826C3CD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C05CD0-03A0-49C1-0204-8A2DBD8BB8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855BA-ED2C-4921-85A3-0B137AC57079}" type="datetimeFigureOut">
              <a:rPr lang="en-US" smtClean="0"/>
              <a:t>3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249884-64AE-09E5-6DBA-4F212768C3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68D848-173C-1CF6-F423-08280D4B0C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525C67-CAC0-4D02-B484-862DB48D8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745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D9226E-02C2-8F0A-0E0F-2C969D75F0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9F6B41C-0CC3-AED6-C81D-554EF689CB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0EFD58-DBE8-32D5-BA21-45AAEA209D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855BA-ED2C-4921-85A3-0B137AC57079}" type="datetimeFigureOut">
              <a:rPr lang="en-US" smtClean="0"/>
              <a:t>3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BD03C1-3096-BA39-C2CE-D12D565AD2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3961B0-BE66-CB48-A470-6C03DC41A5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525C67-CAC0-4D02-B484-862DB48D8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2947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8ACE02-6A5C-4EB0-1510-B3CF6DAF36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2D96437-FDC2-0FE7-179D-4FAB7E25277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EC5D49F-6932-A3F2-6AEC-D9C273C1AE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304A6D-A47B-C756-3B15-26A6F1E3F9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855BA-ED2C-4921-85A3-0B137AC57079}" type="datetimeFigureOut">
              <a:rPr lang="en-US" smtClean="0"/>
              <a:t>3/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CB3A0CB-33D4-4F78-926A-0AF0B4BF3C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E678C4A-B042-6506-C08C-CEA3AE0057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525C67-CAC0-4D02-B484-862DB48D8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32884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6AFF0A-A398-DA2D-3CC8-9B3A2D63CF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90D45C-0476-3A3F-D240-A175FC04D4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E16513E-0B48-7D08-090D-4016C1FCD7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C60F49D-3E2F-D0FD-1B5D-16F0603586B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7E2E3B8-6206-EE2F-115B-17C32E79315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8C3C371-6537-F485-2056-2C3886CBA8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855BA-ED2C-4921-85A3-0B137AC57079}" type="datetimeFigureOut">
              <a:rPr lang="en-US" smtClean="0"/>
              <a:t>3/4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DBBE465-A1F6-8A18-3D8D-2293CA0048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146AD72-0096-893B-D4B6-3052435A74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525C67-CAC0-4D02-B484-862DB48D8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5446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87BAE7-FBCD-DF98-DED3-ACD85F5C68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ACCF1D0-8309-EF3B-1046-55F90ABE42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855BA-ED2C-4921-85A3-0B137AC57079}" type="datetimeFigureOut">
              <a:rPr lang="en-US" smtClean="0"/>
              <a:t>3/4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04CB9CB-57EC-77D5-99B9-CB1801BD60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5FC0BC7-5937-C203-0558-928AE842FD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525C67-CAC0-4D02-B484-862DB48D8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53860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CB81C0B-9DDC-8762-8514-3F3A03C347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855BA-ED2C-4921-85A3-0B137AC57079}" type="datetimeFigureOut">
              <a:rPr lang="en-US" smtClean="0"/>
              <a:t>3/4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17DD6E0-0A24-2B0D-F263-A8755A93A2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16DC3ED-3A57-947C-02B7-7F0B43595C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525C67-CAC0-4D02-B484-862DB48D8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12124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C95AE2-A56A-D7EB-7716-B7D68A04CE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14EA84-B406-8BEF-1965-C29EB60F32A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C11B299-5C15-080C-8A87-324E086D05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488574-E8DF-F48E-BB1F-8451614C0E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855BA-ED2C-4921-85A3-0B137AC57079}" type="datetimeFigureOut">
              <a:rPr lang="en-US" smtClean="0"/>
              <a:t>3/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63DF339-4A87-19B9-95AB-833F9C1C9D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C8A608-C7E8-40DD-75DD-0737EA7E40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525C67-CAC0-4D02-B484-862DB48D8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12129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BA71A1-C5F6-C550-25C8-1517203DB5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05BD1A5-D356-E348-4B53-F68DD1D6B5A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CB1909F-9720-6485-E4AF-07A2934474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320B2B5-E45E-CF9C-487D-7EC9EEA5E0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855BA-ED2C-4921-85A3-0B137AC57079}" type="datetimeFigureOut">
              <a:rPr lang="en-US" smtClean="0"/>
              <a:t>3/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C199A4D-9EC7-8EB0-F915-42A5826441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86307C-DE8F-EFDB-0D14-9DDAB62A3B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525C67-CAC0-4D02-B484-862DB48D8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29041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A99B5C0-8498-12D0-044F-1CA7635638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26C39A6-0953-A7F0-DB02-21C25EB3F0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6A7F34-E604-020F-A754-2099638B31A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D8855BA-ED2C-4921-85A3-0B137AC57079}" type="datetimeFigureOut">
              <a:rPr lang="en-US" smtClean="0"/>
              <a:t>3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3D0C54-CA21-81F9-9D35-C940D5BAF79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8C1A17-AB2C-8427-7543-230F6DF9794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9525C67-CAC0-4D02-B484-862DB48D8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1962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FAA8C629-0A57-DF31-FB0D-E4A70BEE0D4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17825234"/>
              </p:ext>
            </p:extLst>
          </p:nvPr>
        </p:nvGraphicFramePr>
        <p:xfrm>
          <a:off x="4135956" y="340322"/>
          <a:ext cx="4083050" cy="4200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4082859" imgH="4200477" progId="Prism10.Document">
                  <p:embed/>
                </p:oleObj>
              </mc:Choice>
              <mc:Fallback>
                <p:oleObj name="Prism 10" r:id="rId2" imgW="4082859" imgH="4200477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135956" y="340322"/>
                        <a:ext cx="4083050" cy="4200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6CC95E09-BAA3-C8D5-784C-BC746981483B}"/>
              </a:ext>
            </a:extLst>
          </p:cNvPr>
          <p:cNvSpPr txBox="1"/>
          <p:nvPr/>
        </p:nvSpPr>
        <p:spPr>
          <a:xfrm>
            <a:off x="1874068" y="553294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5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685D19A-7DD7-1801-3A56-EF27B39539DC}"/>
              </a:ext>
            </a:extLst>
          </p:cNvPr>
          <p:cNvSpPr txBox="1"/>
          <p:nvPr/>
        </p:nvSpPr>
        <p:spPr>
          <a:xfrm>
            <a:off x="1591900" y="4981267"/>
            <a:ext cx="917116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ure S5. Vehicle administration does not alter the mechanical sensitivity of the mice. </a:t>
            </a:r>
            <a:r>
              <a:rPr lang="en-US" sz="1400" dirty="0"/>
              <a:t>Paw withdrawal threshold change from baseline was measured in wild-type mice at baseline and after 1h, 3h, 6h, 24h of letrozole (0.5mg/kg) or vehicle treatment. Two-way ANOVA with </a:t>
            </a:r>
            <a:r>
              <a:rPr lang="en-US" sz="1400" dirty="0" err="1"/>
              <a:t>Sidak’s</a:t>
            </a:r>
            <a:r>
              <a:rPr lang="en-US" sz="1400" dirty="0"/>
              <a:t> multiple comparison adjustment was used to analyze the data. Data are represented as mean and SD, **** P&lt;0.0001 compared to vehicle.</a:t>
            </a:r>
          </a:p>
        </p:txBody>
      </p:sp>
    </p:spTree>
    <p:extLst>
      <p:ext uri="{BB962C8B-B14F-4D97-AF65-F5344CB8AC3E}">
        <p14:creationId xmlns:p14="http://schemas.microsoft.com/office/powerpoint/2010/main" val="4752395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0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GraphPad Prism Project</vt:lpstr>
      <vt:lpstr>PowerPoint Presentation</vt:lpstr>
    </vt:vector>
  </TitlesOfParts>
  <Company>The Ohio Stat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u, Shuiying</dc:creator>
  <cp:lastModifiedBy>Hu, Shuiying</cp:lastModifiedBy>
  <cp:revision>1</cp:revision>
  <dcterms:created xsi:type="dcterms:W3CDTF">2025-03-05T03:31:06Z</dcterms:created>
  <dcterms:modified xsi:type="dcterms:W3CDTF">2025-03-05T03:31:36Z</dcterms:modified>
</cp:coreProperties>
</file>